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5BB702-6E56-409F-92E0-E3A9986D62E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484AD4-BFAB-40B6-AF3C-CF52D80F61A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A9D5E5-9F65-4730-8726-751CD324C69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A0B45D-D839-4F2F-A253-BF793D96FE7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30F495-16ED-4312-889F-27FEA16FA46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E559D9-AAE5-40B0-9D33-2E0B7E8910E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D06898-4034-4B33-8807-A3D8E678748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03B6D0-5E03-4CE4-9FDA-F6CBE9C3352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7CD512-A525-4FE6-AD09-A24AE9A8DB1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C2AB33-3072-4C15-AFCC-D237543107A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6B7418-44BC-4591-9073-00B8B4694B6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EF8A5F-811E-4D52-88A4-BFA4E67D047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95954B2-B6CB-411F-8570-2258D9E4A31C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Content Placeholder 3" descr="RAV1 conserved domain.png"/>
          <p:cNvPicPr/>
          <p:nvPr/>
        </p:nvPicPr>
        <p:blipFill>
          <a:blip r:embed="rId1"/>
          <a:stretch/>
        </p:blipFill>
        <p:spPr>
          <a:xfrm>
            <a:off x="476280" y="5024520"/>
            <a:ext cx="6172200" cy="47304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2" descr=""/>
          <p:cNvPicPr/>
          <p:nvPr/>
        </p:nvPicPr>
        <p:blipFill>
          <a:blip r:embed="rId2"/>
          <a:srcRect l="0" t="26680" r="1856" b="0"/>
          <a:stretch/>
        </p:blipFill>
        <p:spPr>
          <a:xfrm>
            <a:off x="549360" y="1424160"/>
            <a:ext cx="5616360" cy="2573280"/>
          </a:xfrm>
          <a:prstGeom prst="rect">
            <a:avLst/>
          </a:prstGeom>
          <a:ln w="0">
            <a:noFill/>
          </a:ln>
        </p:spPr>
      </p:pic>
      <p:sp>
        <p:nvSpPr>
          <p:cNvPr id="43" name="TextBox 4"/>
          <p:cNvSpPr/>
          <p:nvPr/>
        </p:nvSpPr>
        <p:spPr>
          <a:xfrm>
            <a:off x="333360" y="272880"/>
            <a:ext cx="287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Supplementary Figure 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5"/>
          <p:cNvSpPr/>
          <p:nvPr/>
        </p:nvSpPr>
        <p:spPr>
          <a:xfrm>
            <a:off x="479160" y="992160"/>
            <a:ext cx="390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A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6"/>
          <p:cNvSpPr/>
          <p:nvPr/>
        </p:nvSpPr>
        <p:spPr>
          <a:xfrm>
            <a:off x="407160" y="4376880"/>
            <a:ext cx="380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B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Rectangle 1"/>
          <p:cNvSpPr/>
          <p:nvPr/>
        </p:nvSpPr>
        <p:spPr>
          <a:xfrm>
            <a:off x="333360" y="6602040"/>
            <a:ext cx="6191280" cy="155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1:  BvRAV1-like/AtRAV1 alignment and BvRAV1-like conserved protein domains</a:t>
            </a:r>
            <a:r>
              <a:rPr b="0" lang="en-GB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Times New Roman"/>
              <a:buAutoNum type="alphaUcParenR"/>
              <a:tabLst>
                <a:tab algn="l" pos="4572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lastX alignment of BvRAV1-like (Locus 29609) with Arabidopsis RAV1 (Gene ID: 837886  AP2/ERF and B3 domain-containing transcription factor) showing 49% sequence identity over 256 amino acids and 66% similarity with a p value of 4e</a:t>
            </a:r>
            <a:r>
              <a:rPr b="0" lang="en-GB" sz="11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-68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)  Conserved protein domains in BvRAV1-like (locus 29609) showing the relative positions of the AP2 and B3 domains at the N- and C-terminus respectively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1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1-08T19:44:21Z</dcterms:created>
  <dc:creator>Effie</dc:creator>
  <dc:description/>
  <dc:language>en-US</dc:language>
  <cp:lastModifiedBy>Effie</cp:lastModifiedBy>
  <cp:lastPrinted>2011-11-14T16:14:22Z</cp:lastPrinted>
  <dcterms:modified xsi:type="dcterms:W3CDTF">2011-11-27T01:01:29Z</dcterms:modified>
  <cp:revision>57</cp:revision>
  <dc:subject/>
  <dc:title>Slide 1</dc:title>
</cp:coreProperties>
</file>